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D59EA-5CB9-4E30-A52A-18E8C0EDAB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0E172-ADA7-40E2-B7AE-5B01EB4CD1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2AE4A-38FE-4898-8A7C-7493181158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7A667-39CF-4720-8292-1E668A5ED2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C8E30B-293C-42EB-A358-9911908830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5B45B9-6C5B-4E8E-9993-5D8957B0E3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A5A9E-1450-4D6D-BC8B-7C836CBBF8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E3E69-B686-4BF0-B1CA-55C3520008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9D1350-99C9-41D3-8CCD-8D38E6E00C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3A406-3CE3-4379-B140-240538310D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D1993F-A197-4C82-A715-C2F28C5FBF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19709B-5DE5-4FEC-AB6D-9094A4DC63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F17D5F-DEA1-4F4B-A73F-19BC4B161870}" type="slidenum">
              <a:rPr b="0" lang="en-GB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 rot="16200000">
            <a:off x="515160" y="5957640"/>
            <a:ext cx="1834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% of cells relative to Day 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5"/>
          <p:cNvSpPr/>
          <p:nvPr/>
        </p:nvSpPr>
        <p:spPr>
          <a:xfrm>
            <a:off x="3182760" y="7383600"/>
            <a:ext cx="42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Da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9"/>
          <p:cNvSpPr/>
          <p:nvPr/>
        </p:nvSpPr>
        <p:spPr>
          <a:xfrm>
            <a:off x="3067200" y="777960"/>
            <a:ext cx="76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HCC7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30" descr=""/>
          <p:cNvPicPr/>
          <p:nvPr/>
        </p:nvPicPr>
        <p:blipFill>
          <a:blip r:embed="rId1"/>
          <a:stretch/>
        </p:blipFill>
        <p:spPr>
          <a:xfrm>
            <a:off x="2374920" y="2700360"/>
            <a:ext cx="2160720" cy="345960"/>
          </a:xfrm>
          <a:prstGeom prst="rect">
            <a:avLst/>
          </a:prstGeom>
          <a:ln w="9360">
            <a:solidFill>
              <a:srgbClr val="0d0d0d"/>
            </a:solidFill>
            <a:miter/>
          </a:ln>
        </p:spPr>
      </p:pic>
      <p:sp>
        <p:nvSpPr>
          <p:cNvPr id="45" name="TextBox 31"/>
          <p:cNvSpPr/>
          <p:nvPr/>
        </p:nvSpPr>
        <p:spPr>
          <a:xfrm>
            <a:off x="1769760" y="2724120"/>
            <a:ext cx="645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1" descr=""/>
          <p:cNvPicPr/>
          <p:nvPr/>
        </p:nvPicPr>
        <p:blipFill>
          <a:blip r:embed="rId2"/>
          <a:srcRect l="0" t="15526" r="4246" b="0"/>
          <a:stretch/>
        </p:blipFill>
        <p:spPr>
          <a:xfrm>
            <a:off x="2370240" y="3525840"/>
            <a:ext cx="2160360" cy="351000"/>
          </a:xfrm>
          <a:prstGeom prst="rect">
            <a:avLst/>
          </a:prstGeom>
          <a:ln w="9360">
            <a:solidFill>
              <a:srgbClr val="0d0d0d"/>
            </a:solidFill>
            <a:miter/>
          </a:ln>
        </p:spPr>
      </p:pic>
      <p:sp>
        <p:nvSpPr>
          <p:cNvPr id="47" name="TextBox 32"/>
          <p:cNvSpPr/>
          <p:nvPr/>
        </p:nvSpPr>
        <p:spPr>
          <a:xfrm>
            <a:off x="1713960" y="3527280"/>
            <a:ext cx="677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ubulin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3"/>
          <p:cNvSpPr/>
          <p:nvPr/>
        </p:nvSpPr>
        <p:spPr>
          <a:xfrm>
            <a:off x="1568520" y="3138480"/>
            <a:ext cx="804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OXO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35" descr=""/>
          <p:cNvPicPr/>
          <p:nvPr/>
        </p:nvPicPr>
        <p:blipFill>
          <a:blip r:embed="rId3"/>
          <a:srcRect l="5137" t="49082" r="0" b="5346"/>
          <a:stretch/>
        </p:blipFill>
        <p:spPr>
          <a:xfrm>
            <a:off x="2376360" y="3105000"/>
            <a:ext cx="2160720" cy="360360"/>
          </a:xfrm>
          <a:prstGeom prst="rect">
            <a:avLst/>
          </a:prstGeom>
          <a:ln w="9360">
            <a:solidFill>
              <a:srgbClr val="0d0d0d"/>
            </a:solidFill>
            <a:miter/>
          </a:ln>
        </p:spPr>
      </p:pic>
      <p:sp>
        <p:nvSpPr>
          <p:cNvPr id="50" name="TextBox 40"/>
          <p:cNvSpPr/>
          <p:nvPr/>
        </p:nvSpPr>
        <p:spPr>
          <a:xfrm rot="18661800">
            <a:off x="2253600" y="1843200"/>
            <a:ext cx="1748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pcDNA3+NSC siRN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41"/>
          <p:cNvSpPr/>
          <p:nvPr/>
        </p:nvSpPr>
        <p:spPr>
          <a:xfrm rot="18558000">
            <a:off x="2877480" y="1859040"/>
            <a:ext cx="16848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BRCA1+NSC siRN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42"/>
          <p:cNvSpPr/>
          <p:nvPr/>
        </p:nvSpPr>
        <p:spPr>
          <a:xfrm rot="18558000">
            <a:off x="3366360" y="1735560"/>
            <a:ext cx="18954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BRCA1+FOXO3 siRN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43"/>
          <p:cNvSpPr/>
          <p:nvPr/>
        </p:nvSpPr>
        <p:spPr>
          <a:xfrm rot="18558000">
            <a:off x="3960000" y="1735560"/>
            <a:ext cx="18954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BRCA1+FOXO3 siRN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4"/>
          <p:cNvSpPr/>
          <p:nvPr/>
        </p:nvSpPr>
        <p:spPr>
          <a:xfrm>
            <a:off x="4948560" y="962964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Chart 20" descr=""/>
          <p:cNvPicPr/>
          <p:nvPr/>
        </p:nvPicPr>
        <p:blipFill>
          <a:blip r:embed="rId4"/>
          <a:stretch/>
        </p:blipFill>
        <p:spPr>
          <a:xfrm>
            <a:off x="1573200" y="4853160"/>
            <a:ext cx="3382920" cy="2558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02T13:43:38Z</dcterms:created>
  <dc:creator>Gong, Chun</dc:creator>
  <dc:description/>
  <dc:language>en-US</dc:language>
  <cp:lastModifiedBy>Satish.d</cp:lastModifiedBy>
  <cp:lastPrinted>2015-11-05T12:17:29Z</cp:lastPrinted>
  <dcterms:modified xsi:type="dcterms:W3CDTF">2016-03-17T14:10:47Z</dcterms:modified>
  <cp:revision>971</cp:revision>
  <dc:subject/>
  <dc:title>Regulation of FOXO3a by BRCA1</dc:title>
</cp:coreProperties>
</file>